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84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custSel addSld modSld">
      <pc:chgData name="Sobel, Raymond" userId="682ea7fd-2081-4ef7-9ccf-cc036b672067" providerId="ADAL" clId="{327064EF-D6E0-4CA7-937D-5219C7D36AD4}" dt="2025-11-02T21:23:15.872" v="150" actId="6549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1:23:15.872" v="150" actId="6549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1:23:15.872" v="150" actId="6549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1:21:53.948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mod">
          <ac:chgData name="Sobel, Raymond" userId="682ea7fd-2081-4ef7-9ccf-cc036b672067" providerId="ADAL" clId="{327064EF-D6E0-4CA7-937D-5219C7D36AD4}" dt="2025-11-02T21:22:43.859" v="146" actId="1076"/>
          <ac:picMkLst>
            <pc:docMk/>
            <pc:sldMk cId="3744564216" sldId="256"/>
            <ac:picMk id="5" creationId="{7ED8A27C-ECD5-5F17-69FE-0128501A0BD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311889" y="5011484"/>
            <a:ext cx="116887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Histopathological findings in muscle biopsy from the </a:t>
            </a:r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patient b. Ligh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croscopy analysis demonstrated: (A) marked fiber size variability, numerous fibers containing multiple cytoplasmic vacuoles, internalized nuclei, fiber splitting, and low increased endomysial connective tissue; (B) a granular or dotted aspect of the muscle cell membrane and red labeling of cytoplasmic vacuoles; (C) absence of myofibrillar disorganization but peripheral accumulations of mitochondria in some fibers; (D, E) predominance of type I fibers and selective atrophy of type II fibers; (F). Abbreviations: GT, Gömöri trichrome; H&amp;E, hematoxylin and eosin; NADH-TR, reduced nicotinamide adenine dinucleotide dehydrogenase-tetrazolium reductase. Scale bar = 100 µm for all panels.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ED8A27C-ECD5-5F17-69FE-0128501A0B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9811" y="182639"/>
            <a:ext cx="8812378" cy="4396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1:23:18Z</dcterms:modified>
</cp:coreProperties>
</file>